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580063" cy="50403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E37F0-88B5-4AED-B52A-9A547E3740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9360" y="1176480"/>
            <a:ext cx="50212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9360" y="2913840"/>
            <a:ext cx="50212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605883-16A4-4F3F-A010-EFB8D8C8BA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9360" y="117648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852280" y="117648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9360" y="291384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852280" y="291384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86210-A942-4B3F-A044-BB69447048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9360" y="1176480"/>
            <a:ext cx="16167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77480" y="1176480"/>
            <a:ext cx="16167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675240" y="1176480"/>
            <a:ext cx="16167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9360" y="2913840"/>
            <a:ext cx="16167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77480" y="2913840"/>
            <a:ext cx="16167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675240" y="2913840"/>
            <a:ext cx="16167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9DEE5-11A8-473C-AFC2-1AB7232CC0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9360" y="1176480"/>
            <a:ext cx="5021280" cy="332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24"/>
              </a:spcBef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8BFAE-3165-4C58-BFAC-3355D2B19D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9360" y="1176480"/>
            <a:ext cx="502128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2CE31-C1D0-4BFD-BAA6-D031C2DCDC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9360" y="1176480"/>
            <a:ext cx="245016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852280" y="1176480"/>
            <a:ext cx="245016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DA3FF-5C0E-4E00-8309-E977096A78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7A4F2-5323-4CFE-8CCA-204D5EF46B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9360" y="201240"/>
            <a:ext cx="5021280" cy="389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24"/>
              </a:spcBef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59C864-062C-4AF0-B49E-4A44F37F79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9360" y="117648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852280" y="1176480"/>
            <a:ext cx="245016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9360" y="291384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DD7B62-EB24-48E8-AE6A-F5FE791A76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9360" y="1176480"/>
            <a:ext cx="245016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852280" y="117648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852280" y="291384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431C16-658A-47FA-A084-D63BF12614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9360" y="117648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852280" y="1176480"/>
            <a:ext cx="245016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9360" y="2913840"/>
            <a:ext cx="5021280" cy="158616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9EB38-EDAD-4D49-B928-96081108F9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9360" y="201240"/>
            <a:ext cx="5021280" cy="8398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 algn="ctr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9360" y="1176480"/>
            <a:ext cx="5021280" cy="332568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t">
            <a:normAutofit/>
          </a:bodyPr>
          <a:p>
            <a:pPr marL="222120" indent="-22212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484200" indent="-18576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744480" indent="-14760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042920" indent="-14760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341360" indent="-1476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341360" indent="-1476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341360" indent="-14760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79360" y="4671720"/>
            <a:ext cx="1301760" cy="26820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  <a:defRPr b="0" lang="it-IT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r>
              <a:rPr b="0" lang="it-IT" sz="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906560" y="4671720"/>
            <a:ext cx="1766880" cy="26820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p>
            <a:pPr indent="0"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998880" y="4671720"/>
            <a:ext cx="1301760" cy="268200"/>
          </a:xfrm>
          <a:prstGeom prst="rect">
            <a:avLst/>
          </a:prstGeom>
          <a:noFill/>
          <a:ln w="0">
            <a:noFill/>
          </a:ln>
        </p:spPr>
        <p:txBody>
          <a:bodyPr lIns="59760" rIns="59760" tIns="29880" bIns="298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  <a:defRPr b="0" lang="it-IT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595440"/>
                <a:tab algn="l" pos="1190520"/>
                <a:tab algn="l" pos="1785960"/>
                <a:tab algn="l" pos="2381400"/>
                <a:tab algn="l" pos="2976480"/>
                <a:tab algn="l" pos="3571920"/>
                <a:tab algn="l" pos="4167360"/>
                <a:tab algn="l" pos="4762440"/>
                <a:tab algn="l" pos="5357880"/>
                <a:tab algn="l" pos="5952960"/>
                <a:tab algn="l" pos="6548400"/>
                <a:tab algn="l" pos="7143840"/>
                <a:tab algn="l" pos="7738920"/>
                <a:tab algn="l" pos="8334360"/>
                <a:tab algn="l" pos="8929800"/>
                <a:tab algn="l" pos="9524880"/>
                <a:tab algn="l" pos="10120320"/>
                <a:tab algn="l" pos="10715760"/>
              </a:tabLst>
            </a:pPr>
            <a:fld id="{A5CF09A1-DBB7-42E2-A9C4-78F7186D3D7A}" type="slidenum">
              <a:rPr b="0" lang="it-IT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3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91"/>
          <p:cNvGrpSpPr/>
          <p:nvPr/>
        </p:nvGrpSpPr>
        <p:grpSpPr>
          <a:xfrm>
            <a:off x="-15840" y="144360"/>
            <a:ext cx="5614560" cy="4920840"/>
            <a:chOff x="-15840" y="144360"/>
            <a:chExt cx="5614560" cy="4920840"/>
          </a:xfrm>
        </p:grpSpPr>
        <p:sp>
          <p:nvSpPr>
            <p:cNvPr id="42" name="CasellaDiTesto 26"/>
            <p:cNvSpPr/>
            <p:nvPr/>
          </p:nvSpPr>
          <p:spPr>
            <a:xfrm rot="16200000">
              <a:off x="-525240" y="2220840"/>
              <a:ext cx="1356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95440"/>
                  <a:tab algn="l" pos="1190520"/>
                  <a:tab algn="l" pos="1785960"/>
                  <a:tab algn="l" pos="2381400"/>
                  <a:tab algn="l" pos="2976480"/>
                  <a:tab algn="l" pos="3571920"/>
                  <a:tab algn="l" pos="4167360"/>
                  <a:tab algn="l" pos="4762440"/>
                  <a:tab algn="l" pos="5357880"/>
                  <a:tab algn="l" pos="5952960"/>
                  <a:tab algn="l" pos="6548400"/>
                  <a:tab algn="l" pos="7143840"/>
                  <a:tab algn="l" pos="7738920"/>
                  <a:tab algn="l" pos="8334360"/>
                  <a:tab algn="l" pos="8929800"/>
                  <a:tab algn="l" pos="9524880"/>
                  <a:tab algn="l" pos="10120320"/>
                  <a:tab algn="l" pos="1071576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Cell</a:t>
              </a:r>
              <a:r>
                <a:rPr b="0" lang="it-IT" sz="1600" spc="-1" strike="noStrike">
                  <a:solidFill>
                    <a:srgbClr val="000000"/>
                  </a:solidFill>
                  <a:latin typeface="Calibri"/>
                </a:rPr>
                <a:t>   </a:t>
              </a: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numb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CasellaDiTesto 27"/>
            <p:cNvSpPr/>
            <p:nvPr/>
          </p:nvSpPr>
          <p:spPr>
            <a:xfrm>
              <a:off x="2048040" y="4758120"/>
              <a:ext cx="2278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595440"/>
                  <a:tab algn="l" pos="1190520"/>
                  <a:tab algn="l" pos="1785960"/>
                  <a:tab algn="l" pos="2381400"/>
                  <a:tab algn="l" pos="2976480"/>
                  <a:tab algn="l" pos="3571920"/>
                  <a:tab algn="l" pos="4167360"/>
                  <a:tab algn="l" pos="4762440"/>
                  <a:tab algn="l" pos="5357880"/>
                  <a:tab algn="l" pos="5952960"/>
                  <a:tab algn="l" pos="6548400"/>
                  <a:tab algn="l" pos="7143840"/>
                  <a:tab algn="l" pos="7738920"/>
                  <a:tab algn="l" pos="8334360"/>
                  <a:tab algn="l" pos="8929800"/>
                  <a:tab algn="l" pos="9524880"/>
                  <a:tab algn="l" pos="10120320"/>
                  <a:tab algn="l" pos="1071576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Calibri"/>
                </a:rPr>
                <a:t>Fluorescence</a:t>
              </a:r>
              <a:r>
                <a:rPr b="1" lang="it-IT" sz="12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it-IT" sz="1400" spc="-1" strike="noStrike">
                  <a:solidFill>
                    <a:srgbClr val="000000"/>
                  </a:solidFill>
                  <a:latin typeface="Calibri"/>
                </a:rPr>
                <a:t>intensit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CasellaDiTesto 30"/>
            <p:cNvSpPr/>
            <p:nvPr/>
          </p:nvSpPr>
          <p:spPr>
            <a:xfrm rot="5400000">
              <a:off x="4761360" y="1089720"/>
              <a:ext cx="136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95440"/>
                  <a:tab algn="l" pos="1190520"/>
                  <a:tab algn="l" pos="1785960"/>
                  <a:tab algn="l" pos="2381400"/>
                  <a:tab algn="l" pos="2976480"/>
                  <a:tab algn="l" pos="3571920"/>
                  <a:tab algn="l" pos="4167360"/>
                  <a:tab algn="l" pos="4762440"/>
                  <a:tab algn="l" pos="5357880"/>
                  <a:tab algn="l" pos="5952960"/>
                  <a:tab algn="l" pos="6548400"/>
                  <a:tab algn="l" pos="7143840"/>
                  <a:tab algn="l" pos="7738920"/>
                  <a:tab algn="l" pos="8334360"/>
                  <a:tab algn="l" pos="8929800"/>
                  <a:tab algn="l" pos="9524880"/>
                  <a:tab algn="l" pos="10120320"/>
                  <a:tab algn="l" pos="1071576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VBL- bodip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CasellaDiTesto 32"/>
            <p:cNvSpPr/>
            <p:nvPr/>
          </p:nvSpPr>
          <p:spPr>
            <a:xfrm rot="5400000">
              <a:off x="4761360" y="3537720"/>
              <a:ext cx="136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95440"/>
                  <a:tab algn="l" pos="1190520"/>
                  <a:tab algn="l" pos="1785960"/>
                  <a:tab algn="l" pos="2381400"/>
                  <a:tab algn="l" pos="2976480"/>
                  <a:tab algn="l" pos="3571920"/>
                  <a:tab algn="l" pos="4167360"/>
                  <a:tab algn="l" pos="4762440"/>
                  <a:tab algn="l" pos="5357880"/>
                  <a:tab algn="l" pos="5952960"/>
                  <a:tab algn="l" pos="6548400"/>
                  <a:tab algn="l" pos="7143840"/>
                  <a:tab algn="l" pos="7738920"/>
                  <a:tab algn="l" pos="8334360"/>
                  <a:tab algn="l" pos="8929800"/>
                  <a:tab algn="l" pos="9524880"/>
                  <a:tab algn="l" pos="10120320"/>
                  <a:tab algn="l" pos="1071576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Calcein-AM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Gruppo 77"/>
            <p:cNvGrpSpPr/>
            <p:nvPr/>
          </p:nvGrpSpPr>
          <p:grpSpPr>
            <a:xfrm>
              <a:off x="318600" y="201960"/>
              <a:ext cx="4971600" cy="4577760"/>
              <a:chOff x="318600" y="201960"/>
              <a:chExt cx="4971600" cy="4577760"/>
            </a:xfrm>
          </p:grpSpPr>
          <p:cxnSp>
            <p:nvCxnSpPr>
              <p:cNvPr id="47" name="Connettore 2 133"/>
              <p:cNvCxnSpPr/>
              <p:nvPr/>
            </p:nvCxnSpPr>
            <p:spPr>
              <a:xfrm flipV="1">
                <a:off x="318600" y="201960"/>
                <a:ext cx="13320" cy="457200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48" name="Line 29"/>
              <p:cNvSpPr/>
              <p:nvPr/>
            </p:nvSpPr>
            <p:spPr>
              <a:xfrm>
                <a:off x="321120" y="4779720"/>
                <a:ext cx="4969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9" name="Gruppo 76"/>
            <p:cNvGrpSpPr/>
            <p:nvPr/>
          </p:nvGrpSpPr>
          <p:grpSpPr>
            <a:xfrm>
              <a:off x="465480" y="144360"/>
              <a:ext cx="4825800" cy="2278800"/>
              <a:chOff x="465480" y="144360"/>
              <a:chExt cx="4825800" cy="2278800"/>
            </a:xfrm>
          </p:grpSpPr>
          <p:grpSp>
            <p:nvGrpSpPr>
              <p:cNvPr id="50" name="Gruppo 68"/>
              <p:cNvGrpSpPr/>
              <p:nvPr/>
            </p:nvGrpSpPr>
            <p:grpSpPr>
              <a:xfrm>
                <a:off x="582840" y="267120"/>
                <a:ext cx="4608000" cy="2107440"/>
                <a:chOff x="582840" y="267120"/>
                <a:chExt cx="4608000" cy="2107440"/>
              </a:xfrm>
            </p:grpSpPr>
            <p:pic>
              <p:nvPicPr>
                <p:cNvPr id="51" name="Picture 54" descr="C:\Users\ascione_alessandro\Desktop\Paper Raltegravir 2012\lavoro finalissimo\PAPER 2013 INFECTIOUS DISEASE\SUPPLEMENATRY DATA\FL-VBLdmso.JPG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582840" y="267120"/>
                  <a:ext cx="2310840" cy="21060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2" name="Picture 53" descr="C:\Users\ascione_alessandro\Desktop\Paper Raltegravir 2012\lavoro finalissimo\PAPER 2013 INFECTIOUS DISEASE\SUPPLEMENATRY DATA\FL-VBL h20.JPG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2880000" y="268560"/>
                  <a:ext cx="2310840" cy="2106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3" name="Line 33"/>
                <p:cNvSpPr/>
                <p:nvPr/>
              </p:nvSpPr>
              <p:spPr>
                <a:xfrm flipH="1">
                  <a:off x="1811160" y="1207440"/>
                  <a:ext cx="358920" cy="4852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Text Box 35"/>
                <p:cNvSpPr/>
                <p:nvPr/>
              </p:nvSpPr>
              <p:spPr>
                <a:xfrm>
                  <a:off x="2062440" y="964440"/>
                  <a:ext cx="48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+Vrp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Line 38"/>
                <p:cNvSpPr/>
                <p:nvPr/>
              </p:nvSpPr>
              <p:spPr>
                <a:xfrm flipH="1">
                  <a:off x="1377720" y="1013760"/>
                  <a:ext cx="216000" cy="4316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Text Box 39"/>
                <p:cNvSpPr/>
                <p:nvPr/>
              </p:nvSpPr>
              <p:spPr>
                <a:xfrm>
                  <a:off x="1312920" y="750240"/>
                  <a:ext cx="1427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Drug-free condi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Line 40"/>
                <p:cNvSpPr/>
                <p:nvPr/>
              </p:nvSpPr>
              <p:spPr>
                <a:xfrm>
                  <a:off x="1234800" y="737640"/>
                  <a:ext cx="71280" cy="707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Text Box 41"/>
                <p:cNvSpPr/>
                <p:nvPr/>
              </p:nvSpPr>
              <p:spPr>
                <a:xfrm>
                  <a:off x="865080" y="443880"/>
                  <a:ext cx="10447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+RALT/DMSO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Line 33"/>
                <p:cNvSpPr/>
                <p:nvPr/>
              </p:nvSpPr>
              <p:spPr>
                <a:xfrm flipH="1">
                  <a:off x="4144320" y="1164600"/>
                  <a:ext cx="358920" cy="4852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Text Box 35"/>
                <p:cNvSpPr/>
                <p:nvPr/>
              </p:nvSpPr>
              <p:spPr>
                <a:xfrm>
                  <a:off x="4395600" y="921600"/>
                  <a:ext cx="48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+Vrp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Line 38"/>
                <p:cNvSpPr/>
                <p:nvPr/>
              </p:nvSpPr>
              <p:spPr>
                <a:xfrm flipH="1">
                  <a:off x="3711240" y="970920"/>
                  <a:ext cx="216000" cy="4316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Text Box 39"/>
                <p:cNvSpPr/>
                <p:nvPr/>
              </p:nvSpPr>
              <p:spPr>
                <a:xfrm>
                  <a:off x="3646080" y="707400"/>
                  <a:ext cx="1427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Drug-free condi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Line 40"/>
                <p:cNvSpPr/>
                <p:nvPr/>
              </p:nvSpPr>
              <p:spPr>
                <a:xfrm>
                  <a:off x="3568320" y="694800"/>
                  <a:ext cx="71280" cy="707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Text Box 41"/>
                <p:cNvSpPr/>
                <p:nvPr/>
              </p:nvSpPr>
              <p:spPr>
                <a:xfrm>
                  <a:off x="3183120" y="429840"/>
                  <a:ext cx="9183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+RALT/H2O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5" name="Rettangolo 117"/>
              <p:cNvSpPr/>
              <p:nvPr/>
            </p:nvSpPr>
            <p:spPr>
              <a:xfrm>
                <a:off x="1545120" y="2243880"/>
                <a:ext cx="2809080" cy="17928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595440"/>
                    <a:tab algn="l" pos="1190520"/>
                    <a:tab algn="l" pos="1785960"/>
                    <a:tab algn="l" pos="2381400"/>
                    <a:tab algn="l" pos="2976480"/>
                    <a:tab algn="l" pos="3571920"/>
                    <a:tab algn="l" pos="4167360"/>
                    <a:tab algn="l" pos="4762440"/>
                    <a:tab algn="l" pos="5357880"/>
                    <a:tab algn="l" pos="5952960"/>
                    <a:tab algn="l" pos="6548400"/>
                    <a:tab algn="l" pos="7143840"/>
                    <a:tab algn="l" pos="7738920"/>
                    <a:tab algn="l" pos="8334360"/>
                    <a:tab algn="l" pos="8929800"/>
                    <a:tab algn="l" pos="9524880"/>
                    <a:tab algn="l" pos="10120320"/>
                    <a:tab algn="l" pos="1071576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ttangolo arrotondato 118"/>
              <p:cNvSpPr/>
              <p:nvPr/>
            </p:nvSpPr>
            <p:spPr>
              <a:xfrm>
                <a:off x="465480" y="144360"/>
                <a:ext cx="4825800" cy="2231280"/>
              </a:xfrm>
              <a:prstGeom prst="roundRect">
                <a:avLst>
                  <a:gd name="adj" fmla="val 16667"/>
                </a:avLst>
              </a:prstGeom>
              <a:noFill/>
              <a:ln w="25560">
                <a:solidFill>
                  <a:srgbClr val="d9d9d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595440"/>
                    <a:tab algn="l" pos="1190520"/>
                    <a:tab algn="l" pos="1785960"/>
                    <a:tab algn="l" pos="2381400"/>
                    <a:tab algn="l" pos="2976480"/>
                    <a:tab algn="l" pos="3571920"/>
                    <a:tab algn="l" pos="4167360"/>
                    <a:tab algn="l" pos="4762440"/>
                    <a:tab algn="l" pos="5357880"/>
                    <a:tab algn="l" pos="5952960"/>
                    <a:tab algn="l" pos="6548400"/>
                    <a:tab algn="l" pos="7143840"/>
                    <a:tab algn="l" pos="7738920"/>
                    <a:tab algn="l" pos="8334360"/>
                    <a:tab algn="l" pos="8929800"/>
                    <a:tab algn="l" pos="9524880"/>
                    <a:tab algn="l" pos="10120320"/>
                    <a:tab algn="l" pos="1071576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7" name="Gruppo 75"/>
            <p:cNvGrpSpPr/>
            <p:nvPr/>
          </p:nvGrpSpPr>
          <p:grpSpPr>
            <a:xfrm>
              <a:off x="465480" y="2431440"/>
              <a:ext cx="4825800" cy="2278800"/>
              <a:chOff x="465480" y="2431440"/>
              <a:chExt cx="4825800" cy="2278800"/>
            </a:xfrm>
          </p:grpSpPr>
          <p:grpSp>
            <p:nvGrpSpPr>
              <p:cNvPr id="68" name="Gruppo 69"/>
              <p:cNvGrpSpPr/>
              <p:nvPr/>
            </p:nvGrpSpPr>
            <p:grpSpPr>
              <a:xfrm>
                <a:off x="574560" y="2559600"/>
                <a:ext cx="4627440" cy="2107080"/>
                <a:chOff x="574560" y="2559600"/>
                <a:chExt cx="4627440" cy="2107080"/>
              </a:xfrm>
            </p:grpSpPr>
            <p:pic>
              <p:nvPicPr>
                <p:cNvPr id="69" name="Picture 55" descr="C:\Users\ascione_alessandro\Desktop\Paper Raltegravir 2012\lavoro finalissimo\PAPER 2013 INFECTIOUS DISEASE\SUPPLEMENATRY DATA\CalcAM h2o.JPG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2891160" y="2559600"/>
                  <a:ext cx="2310840" cy="2107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0" name="Picture 56" descr="C:\Users\ascione_alessandro\Desktop\Paper Raltegravir 2012\lavoro finalissimo\PAPER 2013 INFECTIOUS DISEASE\SUPPLEMENATRY DATA\Calc.AM DMSO.JPG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574560" y="2559600"/>
                  <a:ext cx="2310840" cy="21070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1" name="Line 33"/>
                <p:cNvSpPr/>
                <p:nvPr/>
              </p:nvSpPr>
              <p:spPr>
                <a:xfrm>
                  <a:off x="2389320" y="3683520"/>
                  <a:ext cx="0" cy="244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Text Box 35"/>
                <p:cNvSpPr/>
                <p:nvPr/>
              </p:nvSpPr>
              <p:spPr>
                <a:xfrm>
                  <a:off x="2102040" y="3363480"/>
                  <a:ext cx="48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+Vrp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Line 38"/>
                <p:cNvSpPr/>
                <p:nvPr/>
              </p:nvSpPr>
              <p:spPr>
                <a:xfrm>
                  <a:off x="1668960" y="3345840"/>
                  <a:ext cx="0" cy="5101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Text Box 39"/>
                <p:cNvSpPr/>
                <p:nvPr/>
              </p:nvSpPr>
              <p:spPr>
                <a:xfrm>
                  <a:off x="907920" y="2705400"/>
                  <a:ext cx="1427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Drug-free condi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Line 40"/>
                <p:cNvSpPr/>
                <p:nvPr/>
              </p:nvSpPr>
              <p:spPr>
                <a:xfrm>
                  <a:off x="1246320" y="2997360"/>
                  <a:ext cx="134280" cy="858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Text Box 41"/>
                <p:cNvSpPr/>
                <p:nvPr/>
              </p:nvSpPr>
              <p:spPr>
                <a:xfrm>
                  <a:off x="1323000" y="3092400"/>
                  <a:ext cx="10447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+RALT/DMSO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Line 33"/>
                <p:cNvSpPr/>
                <p:nvPr/>
              </p:nvSpPr>
              <p:spPr>
                <a:xfrm>
                  <a:off x="4623120" y="3438720"/>
                  <a:ext cx="38520" cy="4172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Text Box 35"/>
                <p:cNvSpPr/>
                <p:nvPr/>
              </p:nvSpPr>
              <p:spPr>
                <a:xfrm>
                  <a:off x="4390920" y="3195720"/>
                  <a:ext cx="48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+Vrp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Line 38"/>
                <p:cNvSpPr/>
                <p:nvPr/>
              </p:nvSpPr>
              <p:spPr>
                <a:xfrm flipH="1">
                  <a:off x="3902400" y="3245040"/>
                  <a:ext cx="19440" cy="6109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Text Box 39"/>
                <p:cNvSpPr/>
                <p:nvPr/>
              </p:nvSpPr>
              <p:spPr>
                <a:xfrm>
                  <a:off x="3231720" y="2698200"/>
                  <a:ext cx="1427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Drug-free condi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Line 40"/>
                <p:cNvSpPr/>
                <p:nvPr/>
              </p:nvSpPr>
              <p:spPr>
                <a:xfrm>
                  <a:off x="3563280" y="2968560"/>
                  <a:ext cx="123120" cy="815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Text Box 41"/>
                <p:cNvSpPr/>
                <p:nvPr/>
              </p:nvSpPr>
              <p:spPr>
                <a:xfrm>
                  <a:off x="3630960" y="2981880"/>
                  <a:ext cx="9183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595440"/>
                      <a:tab algn="l" pos="1190520"/>
                      <a:tab algn="l" pos="1785960"/>
                      <a:tab algn="l" pos="2381400"/>
                      <a:tab algn="l" pos="2976480"/>
                      <a:tab algn="l" pos="3571920"/>
                      <a:tab algn="l" pos="4167360"/>
                      <a:tab algn="l" pos="4762440"/>
                      <a:tab algn="l" pos="5357880"/>
                      <a:tab algn="l" pos="5952960"/>
                      <a:tab algn="l" pos="6548400"/>
                      <a:tab algn="l" pos="7143840"/>
                      <a:tab algn="l" pos="7738920"/>
                      <a:tab algn="l" pos="8334360"/>
                      <a:tab algn="l" pos="8929800"/>
                      <a:tab algn="l" pos="9524880"/>
                      <a:tab algn="l" pos="10120320"/>
                      <a:tab algn="l" pos="1071576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Calibri"/>
                    </a:rPr>
                    <a:t>+RALT/H2O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3" name="Rettangolo 100"/>
              <p:cNvSpPr/>
              <p:nvPr/>
            </p:nvSpPr>
            <p:spPr>
              <a:xfrm>
                <a:off x="1545120" y="4530960"/>
                <a:ext cx="2809080" cy="17928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595440"/>
                    <a:tab algn="l" pos="1190520"/>
                    <a:tab algn="l" pos="1785960"/>
                    <a:tab algn="l" pos="2381400"/>
                    <a:tab algn="l" pos="2976480"/>
                    <a:tab algn="l" pos="3571920"/>
                    <a:tab algn="l" pos="4167360"/>
                    <a:tab algn="l" pos="4762440"/>
                    <a:tab algn="l" pos="5357880"/>
                    <a:tab algn="l" pos="5952960"/>
                    <a:tab algn="l" pos="6548400"/>
                    <a:tab algn="l" pos="7143840"/>
                    <a:tab algn="l" pos="7738920"/>
                    <a:tab algn="l" pos="8334360"/>
                    <a:tab algn="l" pos="8929800"/>
                    <a:tab algn="l" pos="9524880"/>
                    <a:tab algn="l" pos="10120320"/>
                    <a:tab algn="l" pos="1071576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Rettangolo arrotondato 101"/>
              <p:cNvSpPr/>
              <p:nvPr/>
            </p:nvSpPr>
            <p:spPr>
              <a:xfrm>
                <a:off x="465480" y="2431440"/>
                <a:ext cx="4825800" cy="2231280"/>
              </a:xfrm>
              <a:prstGeom prst="roundRect">
                <a:avLst>
                  <a:gd name="adj" fmla="val 16667"/>
                </a:avLst>
              </a:prstGeom>
              <a:noFill/>
              <a:ln w="25560">
                <a:solidFill>
                  <a:srgbClr val="d9d9d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595440"/>
                    <a:tab algn="l" pos="1190520"/>
                    <a:tab algn="l" pos="1785960"/>
                    <a:tab algn="l" pos="2381400"/>
                    <a:tab algn="l" pos="2976480"/>
                    <a:tab algn="l" pos="3571920"/>
                    <a:tab algn="l" pos="4167360"/>
                    <a:tab algn="l" pos="4762440"/>
                    <a:tab algn="l" pos="5357880"/>
                    <a:tab algn="l" pos="5952960"/>
                    <a:tab algn="l" pos="6548400"/>
                    <a:tab algn="l" pos="7143840"/>
                    <a:tab algn="l" pos="7738920"/>
                    <a:tab algn="l" pos="8334360"/>
                    <a:tab algn="l" pos="8929800"/>
                    <a:tab algn="l" pos="9524880"/>
                    <a:tab algn="l" pos="10120320"/>
                    <a:tab algn="l" pos="1071576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05T15:45:27Z</dcterms:created>
  <dc:creator>ascione_alessandro</dc:creator>
  <dc:description/>
  <dc:language>en-US</dc:language>
  <cp:lastModifiedBy>ascione_alessandro</cp:lastModifiedBy>
  <dcterms:modified xsi:type="dcterms:W3CDTF">2013-08-12T09:52:25Z</dcterms:modified>
  <cp:revision>4</cp:revision>
  <dc:subject/>
  <dc:title>Diapositiva 1</dc:title>
</cp:coreProperties>
</file>